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63" r:id="rId3"/>
    <p:sldId id="260" r:id="rId4"/>
    <p:sldId id="261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85"/>
    <p:restoredTop sz="94575"/>
  </p:normalViewPr>
  <p:slideViewPr>
    <p:cSldViewPr snapToGrid="0">
      <p:cViewPr varScale="1">
        <p:scale>
          <a:sx n="130" d="100"/>
          <a:sy n="130" d="100"/>
        </p:scale>
        <p:origin x="21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7773F3-4DC0-7ACD-82FF-67AEE81C04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2EF1C5-EFA1-BFCD-147F-D4C324313C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84F19A-408C-9A14-C312-0FE70E56D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E82559-C702-BAEF-D608-215177EAD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977B10-7693-B21C-24B6-855730A9F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788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3BC242-4D90-5DEA-3330-67614A5CD2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1F7AD2-B5D5-6BC6-3DEA-053CD0AB4F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AA9A98-B075-3D00-0C94-E11CDBE87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D7C733-9A62-5E8C-D166-F77F83A37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6C1D25-0553-E90A-23E5-C48D0EEF6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918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BFE699-9308-1950-F897-5A1D92B3AE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BB5080-56C9-1FF3-C213-6F2A9DC987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389278-E850-CD33-C699-F11F12613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8C2C5D-3139-6118-0860-A62B2E35E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358D02-B433-FDCD-179A-BBDB7E7CF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436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FEBEA8-F9DA-F030-B989-CF5BF728B1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E52C45-E730-0001-683D-8203D6D17A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41A836-6E09-50EF-06FD-34903AB3C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95DEDB-94E0-70EF-DF85-E7D0C4B99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D4E72B-53D5-E561-BEA5-76ECF5B71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137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ABB0E-7262-AACC-23CE-5E7031816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4E1830-56C8-42E7-E981-5803452CE7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B9D9EC-B15A-F298-13E0-E25AA350C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344F79-0890-453E-49F2-76CE7F7D3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ACD6DE-7857-C2C3-8C33-C4B0A4751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9117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2C2B0C-2E12-B5E1-6F27-762EBA1BE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71C801-83AA-85B2-B718-1E293018C6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A3517B-85ED-E32C-869E-CA561F01B7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0AC62E-CB9D-DBB6-545B-6DD63B9BD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9A4749-AF37-3528-32CB-4A15AA964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56E68F-73E9-787B-49B8-82D56ADE1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308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8F776-0E4E-96FB-7339-59EFB866DD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BA515A-D14D-98E9-4DA4-7CF563256B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A8CA94-9C2B-3475-AD1D-8F0BE33EC1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9CC053-CE75-CEDA-0BE9-80FB43BD0E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17E30F-D7CE-CFB8-1479-4FECDAB3F8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CF711E6-570A-5A8D-5430-E560764E9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7A807A-0922-2CD1-3036-AF50434FF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51CE17-359A-A8CB-5345-AF6DE29D7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49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640C1-81CD-07EC-8B39-4B70659DF1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51C7E4-8DA8-E651-2A7B-6DACF34AA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1F50BA-80BB-9FCC-EDB3-C2AF257E4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200DEA-B5A0-B20D-0632-255D16817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9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EB5FB6D-CC0C-BAD9-C248-7B8587C1F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A0C908F-B774-D879-42A8-03E6921F5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E683FD-2078-D5CA-2FB7-4AD286EA1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539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891C4-D4D2-3568-6253-538DBC7EE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F9EAB4-88A8-81C8-1F0C-4A5DF39922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5338EE-D3CC-5EC4-1B53-1AFA65D005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1DBB46-CEE9-A801-AF30-D2884AEA6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C2EFEB-C2FF-6409-4B33-3B4E06A1B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8335FB-0339-7E97-9008-14C6F72D0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120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BF9B24-AFC7-97A9-9CF1-5855E4E1F0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581A3A-4A2E-3D14-2DE0-44C724004B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483511-8205-6FD5-F5CA-FCD46A8933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E3E5C8-3FAA-BA4A-13C1-0B201CD95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79EC15-6B16-B536-CAC7-59412A15D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AD637E-494D-E22C-7AB5-9F13FD957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396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96D885-257D-8ABD-1F84-460226CB8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2D7131-E056-70FA-629E-A4D72B0233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A4ADF-ACCC-D884-7F54-E29572BD7B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7D3FF-502D-9644-941E-E5DF03F67680}" type="datetimeFigureOut">
              <a:rPr lang="en-US" smtClean="0"/>
              <a:t>12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C53DB9-5386-99D6-E11C-82937F9FD3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9E1D70-4F7B-359C-64A0-23E1452D40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36AA5F-528D-BC46-83BC-5D77F0D90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544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diagram of a model&#10;&#10;Description automatically generated with medium confidence">
            <a:extLst>
              <a:ext uri="{FF2B5EF4-FFF2-40B4-BE49-F238E27FC236}">
                <a16:creationId xmlns:a16="http://schemas.microsoft.com/office/drawing/2014/main" id="{FD87564D-8420-BC43-CD2C-EB1E971E78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9858" y="57749"/>
            <a:ext cx="4575897" cy="378117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0A89F9E-D49B-843E-B8A5-7C638CABAFC3}"/>
              </a:ext>
            </a:extLst>
          </p:cNvPr>
          <p:cNvSpPr txBox="1"/>
          <p:nvPr/>
        </p:nvSpPr>
        <p:spPr>
          <a:xfrm>
            <a:off x="2276896" y="28249"/>
            <a:ext cx="3696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.</a:t>
            </a:r>
            <a:endParaRPr lang="en-US" sz="11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E9F95A-705A-B1A6-CDF7-775419FD2C2D}"/>
              </a:ext>
            </a:extLst>
          </p:cNvPr>
          <p:cNvSpPr txBox="1"/>
          <p:nvPr/>
        </p:nvSpPr>
        <p:spPr>
          <a:xfrm>
            <a:off x="7105755" y="0"/>
            <a:ext cx="354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CA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sz="11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26969C9-2AEE-B062-BFE3-32F3A33E626B}"/>
              </a:ext>
            </a:extLst>
          </p:cNvPr>
          <p:cNvSpPr txBox="1"/>
          <p:nvPr/>
        </p:nvSpPr>
        <p:spPr>
          <a:xfrm>
            <a:off x="27983" y="57749"/>
            <a:ext cx="240046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4: Forest Plot for MDD </a:t>
            </a:r>
          </a:p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lapse in Primary Care by </a:t>
            </a:r>
          </a:p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ecific Interventions: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cidence Rate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evention of MDD Relapse</a:t>
            </a:r>
            <a:r>
              <a:rPr lang="en-CA" sz="1200" dirty="0">
                <a:effectLst/>
              </a:rPr>
              <a:t>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CA" sz="1200" dirty="0">
                <a:effectLst/>
              </a:rPr>
              <a:t>  </a:t>
            </a:r>
            <a:endParaRPr lang="en-US" sz="1200" dirty="0"/>
          </a:p>
        </p:txBody>
      </p:sp>
      <p:pic>
        <p:nvPicPr>
          <p:cNvPr id="5" name="Picture 4" descr="A group of graphs and numbers&#10;&#10;Description automatically generated">
            <a:extLst>
              <a:ext uri="{FF2B5EF4-FFF2-40B4-BE49-F238E27FC236}">
                <a16:creationId xmlns:a16="http://schemas.microsoft.com/office/drawing/2014/main" id="{F262138E-CF30-218A-092C-E2CDF8B698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74194" y="28249"/>
            <a:ext cx="4789823" cy="38849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4208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21A0FB46-FE16-FDA0-CFD1-DC7A0EBDB998}"/>
              </a:ext>
            </a:extLst>
          </p:cNvPr>
          <p:cNvSpPr txBox="1"/>
          <p:nvPr/>
        </p:nvSpPr>
        <p:spPr>
          <a:xfrm>
            <a:off x="0" y="0"/>
            <a:ext cx="240046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5: Forest Plot for MDD </a:t>
            </a:r>
          </a:p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lapse in Primary Care by </a:t>
            </a:r>
          </a:p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tudy Design: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cidence Rate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evention of MDD Relapse</a:t>
            </a:r>
            <a:r>
              <a:rPr lang="en-CA" sz="1200" dirty="0">
                <a:effectLst/>
              </a:rPr>
              <a:t>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CA" sz="1200" dirty="0">
                <a:effectLst/>
              </a:rPr>
              <a:t>  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A89F9E-D49B-843E-B8A5-7C638CABAFC3}"/>
              </a:ext>
            </a:extLst>
          </p:cNvPr>
          <p:cNvSpPr txBox="1"/>
          <p:nvPr/>
        </p:nvSpPr>
        <p:spPr>
          <a:xfrm>
            <a:off x="2458054" y="-31696"/>
            <a:ext cx="383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.</a:t>
            </a:r>
            <a:endParaRPr 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E9F95A-705A-B1A6-CDF7-775419FD2C2D}"/>
              </a:ext>
            </a:extLst>
          </p:cNvPr>
          <p:cNvSpPr txBox="1"/>
          <p:nvPr/>
        </p:nvSpPr>
        <p:spPr>
          <a:xfrm>
            <a:off x="7043173" y="-73056"/>
            <a:ext cx="354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sz="1200" dirty="0"/>
          </a:p>
        </p:txBody>
      </p:sp>
      <p:pic>
        <p:nvPicPr>
          <p:cNvPr id="8" name="Picture 7" descr="A screenshot of a graph&#10;&#10;Description automatically generated">
            <a:extLst>
              <a:ext uri="{FF2B5EF4-FFF2-40B4-BE49-F238E27FC236}">
                <a16:creationId xmlns:a16="http://schemas.microsoft.com/office/drawing/2014/main" id="{047CA936-0B35-AB9F-B0D5-A8F3D6C0A2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9081" y="0"/>
            <a:ext cx="4210910" cy="6858000"/>
          </a:xfrm>
          <a:prstGeom prst="rect">
            <a:avLst/>
          </a:prstGeom>
        </p:spPr>
      </p:pic>
      <p:pic>
        <p:nvPicPr>
          <p:cNvPr id="11" name="Picture 10" descr="A graph with numbers and a line&#10;&#10;Description automatically generated with medium confidence">
            <a:extLst>
              <a:ext uri="{FF2B5EF4-FFF2-40B4-BE49-F238E27FC236}">
                <a16:creationId xmlns:a16="http://schemas.microsoft.com/office/drawing/2014/main" id="{7D7C66F2-7A1D-0D63-CD3D-C85CDA5915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09538" y="0"/>
            <a:ext cx="460803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79188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21A0FB46-FE16-FDA0-CFD1-DC7A0EBDB998}"/>
              </a:ext>
            </a:extLst>
          </p:cNvPr>
          <p:cNvSpPr txBox="1"/>
          <p:nvPr/>
        </p:nvSpPr>
        <p:spPr>
          <a:xfrm>
            <a:off x="0" y="0"/>
            <a:ext cx="240046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6: </a:t>
            </a:r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orest Plot for MDD </a:t>
            </a:r>
          </a:p>
          <a:p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lapse in Primary Care </a:t>
            </a:r>
          </a:p>
          <a:p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y Length of Follow up: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cidence Rate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evention of MDD Relapse</a:t>
            </a:r>
            <a:r>
              <a:rPr lang="en-CA" sz="1200" dirty="0">
                <a:effectLst/>
              </a:rPr>
              <a:t>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CA" sz="1200" dirty="0">
                <a:effectLst/>
              </a:rPr>
              <a:t>  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A89F9E-D49B-843E-B8A5-7C638CABAFC3}"/>
              </a:ext>
            </a:extLst>
          </p:cNvPr>
          <p:cNvSpPr txBox="1"/>
          <p:nvPr/>
        </p:nvSpPr>
        <p:spPr>
          <a:xfrm>
            <a:off x="2427972" y="-31698"/>
            <a:ext cx="3836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.</a:t>
            </a:r>
            <a:endParaRPr lang="en-US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E9F95A-705A-B1A6-CDF7-775419FD2C2D}"/>
              </a:ext>
            </a:extLst>
          </p:cNvPr>
          <p:cNvSpPr txBox="1"/>
          <p:nvPr/>
        </p:nvSpPr>
        <p:spPr>
          <a:xfrm>
            <a:off x="7068744" y="-31697"/>
            <a:ext cx="3542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CA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sz="1000" dirty="0"/>
          </a:p>
        </p:txBody>
      </p:sp>
      <p:pic>
        <p:nvPicPr>
          <p:cNvPr id="16" name="Picture 15" descr="A screenshot of a graph&#10;&#10;Description automatically generated">
            <a:extLst>
              <a:ext uri="{FF2B5EF4-FFF2-40B4-BE49-F238E27FC236}">
                <a16:creationId xmlns:a16="http://schemas.microsoft.com/office/drawing/2014/main" id="{03B03C3B-5286-83B6-9D2E-675C017B94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3684" y="0"/>
            <a:ext cx="3422316" cy="6858000"/>
          </a:xfrm>
          <a:prstGeom prst="rect">
            <a:avLst/>
          </a:prstGeom>
        </p:spPr>
      </p:pic>
      <p:pic>
        <p:nvPicPr>
          <p:cNvPr id="18" name="Picture 17" descr="A screenshot of a graph&#10;&#10;Description automatically generated">
            <a:extLst>
              <a:ext uri="{FF2B5EF4-FFF2-40B4-BE49-F238E27FC236}">
                <a16:creationId xmlns:a16="http://schemas.microsoft.com/office/drawing/2014/main" id="{F8D051E6-9174-EB1B-72AA-F8E1F4889D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14043" y="0"/>
            <a:ext cx="339865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64409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21A0FB46-FE16-FDA0-CFD1-DC7A0EBDB998}"/>
              </a:ext>
            </a:extLst>
          </p:cNvPr>
          <p:cNvSpPr txBox="1"/>
          <p:nvPr/>
        </p:nvSpPr>
        <p:spPr>
          <a:xfrm>
            <a:off x="0" y="0"/>
            <a:ext cx="240046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7: </a:t>
            </a:r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orest Plot for MDD </a:t>
            </a:r>
          </a:p>
          <a:p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lapse in Primary Care </a:t>
            </a:r>
          </a:p>
          <a:p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y Publication Year: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cidence Rate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evention of MDD Relapse</a:t>
            </a:r>
            <a:r>
              <a:rPr lang="en-CA" sz="1200" dirty="0">
                <a:effectLst/>
              </a:rPr>
              <a:t>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CA" sz="1200" dirty="0">
                <a:effectLst/>
              </a:rPr>
              <a:t>  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A89F9E-D49B-843E-B8A5-7C638CABAFC3}"/>
              </a:ext>
            </a:extLst>
          </p:cNvPr>
          <p:cNvSpPr txBox="1"/>
          <p:nvPr/>
        </p:nvSpPr>
        <p:spPr>
          <a:xfrm>
            <a:off x="2427972" y="-31698"/>
            <a:ext cx="3836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.</a:t>
            </a:r>
            <a:endParaRPr lang="en-US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E9F95A-705A-B1A6-CDF7-775419FD2C2D}"/>
              </a:ext>
            </a:extLst>
          </p:cNvPr>
          <p:cNvSpPr txBox="1"/>
          <p:nvPr/>
        </p:nvSpPr>
        <p:spPr>
          <a:xfrm>
            <a:off x="7068744" y="-31697"/>
            <a:ext cx="3542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CA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sz="1000" dirty="0"/>
          </a:p>
        </p:txBody>
      </p:sp>
      <p:pic>
        <p:nvPicPr>
          <p:cNvPr id="5" name="Picture 4" descr="A close-up of a graph&#10;&#10;Description automatically generated">
            <a:extLst>
              <a:ext uri="{FF2B5EF4-FFF2-40B4-BE49-F238E27FC236}">
                <a16:creationId xmlns:a16="http://schemas.microsoft.com/office/drawing/2014/main" id="{E4E2FCC2-BC96-7AA5-D023-2213DE40B1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35931" y="0"/>
            <a:ext cx="2848308" cy="6858000"/>
          </a:xfrm>
          <a:prstGeom prst="rect">
            <a:avLst/>
          </a:prstGeom>
        </p:spPr>
      </p:pic>
      <p:pic>
        <p:nvPicPr>
          <p:cNvPr id="7" name="Picture 6" descr="A screenshot of a graph&#10;&#10;Description automatically generated">
            <a:extLst>
              <a:ext uri="{FF2B5EF4-FFF2-40B4-BE49-F238E27FC236}">
                <a16:creationId xmlns:a16="http://schemas.microsoft.com/office/drawing/2014/main" id="{B3C72BF2-B3FD-D7F8-E140-FCEB09CD4F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9845" y="0"/>
            <a:ext cx="339615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89447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21A0FB46-FE16-FDA0-CFD1-DC7A0EBDB998}"/>
              </a:ext>
            </a:extLst>
          </p:cNvPr>
          <p:cNvSpPr txBox="1"/>
          <p:nvPr/>
        </p:nvSpPr>
        <p:spPr>
          <a:xfrm>
            <a:off x="0" y="0"/>
            <a:ext cx="2545890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8: </a:t>
            </a:r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orest Plot for MDD </a:t>
            </a:r>
          </a:p>
          <a:p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lapse in Primary Care in Studies </a:t>
            </a:r>
          </a:p>
          <a:p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f Quality Score </a:t>
            </a:r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</a:t>
            </a:r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85</a:t>
            </a:r>
            <a:r>
              <a:rPr lang="en-CA" sz="1200" dirty="0">
                <a:effectLst/>
              </a:rPr>
              <a:t> </a:t>
            </a:r>
            <a:r>
              <a:rPr lang="en-CA" sz="12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cidence Rate </a:t>
            </a:r>
          </a:p>
          <a:p>
            <a:pPr marL="228600" indent="-228600">
              <a:buAutoNum type="alphaUcPeriod"/>
            </a:pP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evention of MDD Relapse</a:t>
            </a:r>
            <a:r>
              <a:rPr lang="en-CA" sz="1200" dirty="0">
                <a:effectLst/>
              </a:rPr>
              <a:t> </a:t>
            </a:r>
            <a:r>
              <a:rPr lang="en-CA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CA" sz="1200" dirty="0">
                <a:effectLst/>
              </a:rPr>
              <a:t>  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A89F9E-D49B-843E-B8A5-7C638CABAFC3}"/>
              </a:ext>
            </a:extLst>
          </p:cNvPr>
          <p:cNvSpPr txBox="1"/>
          <p:nvPr/>
        </p:nvSpPr>
        <p:spPr>
          <a:xfrm>
            <a:off x="2427972" y="-31698"/>
            <a:ext cx="3836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.</a:t>
            </a:r>
            <a:endParaRPr lang="en-US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E9F95A-705A-B1A6-CDF7-775419FD2C2D}"/>
              </a:ext>
            </a:extLst>
          </p:cNvPr>
          <p:cNvSpPr txBox="1"/>
          <p:nvPr/>
        </p:nvSpPr>
        <p:spPr>
          <a:xfrm>
            <a:off x="7399670" y="0"/>
            <a:ext cx="3542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CA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sz="1000" dirty="0"/>
          </a:p>
        </p:txBody>
      </p:sp>
      <p:pic>
        <p:nvPicPr>
          <p:cNvPr id="3" name="Picture 2" descr="A screenshot of a graph&#10;&#10;Description automatically generated">
            <a:extLst>
              <a:ext uri="{FF2B5EF4-FFF2-40B4-BE49-F238E27FC236}">
                <a16:creationId xmlns:a16="http://schemas.microsoft.com/office/drawing/2014/main" id="{EC3B24C2-AD2F-AB96-786B-7512CE3C3E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9892" y="1"/>
            <a:ext cx="4525775" cy="4206240"/>
          </a:xfrm>
          <a:prstGeom prst="rect">
            <a:avLst/>
          </a:prstGeom>
        </p:spPr>
      </p:pic>
      <p:pic>
        <p:nvPicPr>
          <p:cNvPr id="6" name="Picture 5" descr="A graph with numbers and a line&#10;&#10;Description automatically generated">
            <a:extLst>
              <a:ext uri="{FF2B5EF4-FFF2-40B4-BE49-F238E27FC236}">
                <a16:creationId xmlns:a16="http://schemas.microsoft.com/office/drawing/2014/main" id="{509643A1-498A-7100-D406-8ED8CD6842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66225" y="0"/>
            <a:ext cx="4525775" cy="4206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11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131</Words>
  <Application>Microsoft Macintosh PowerPoint</Application>
  <PresentationFormat>Widescreen</PresentationFormat>
  <Paragraphs>3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our, Waseem Mohammed Abu</dc:creator>
  <cp:lastModifiedBy>Ashour, Waseem Mohammed Abu</cp:lastModifiedBy>
  <cp:revision>8</cp:revision>
  <dcterms:created xsi:type="dcterms:W3CDTF">2024-11-02T18:06:57Z</dcterms:created>
  <dcterms:modified xsi:type="dcterms:W3CDTF">2024-12-18T20:25:48Z</dcterms:modified>
</cp:coreProperties>
</file>